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6" d="100"/>
          <a:sy n="66" d="100"/>
        </p:scale>
        <p:origin x="600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4A258-A6D2-4347-9425-044DB0CE073A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8F672-1CE0-4C8A-8697-46E26BF7B0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2585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4A258-A6D2-4347-9425-044DB0CE073A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8F672-1CE0-4C8A-8697-46E26BF7B0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89784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4A258-A6D2-4347-9425-044DB0CE073A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8F672-1CE0-4C8A-8697-46E26BF7B0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73401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4A258-A6D2-4347-9425-044DB0CE073A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8F672-1CE0-4C8A-8697-46E26BF7B0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94632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4A258-A6D2-4347-9425-044DB0CE073A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8F672-1CE0-4C8A-8697-46E26BF7B0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24317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4A258-A6D2-4347-9425-044DB0CE073A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8F672-1CE0-4C8A-8697-46E26BF7B0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7201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4A258-A6D2-4347-9425-044DB0CE073A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8F672-1CE0-4C8A-8697-46E26BF7B0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50991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4A258-A6D2-4347-9425-044DB0CE073A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8F672-1CE0-4C8A-8697-46E26BF7B0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53650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4A258-A6D2-4347-9425-044DB0CE073A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8F672-1CE0-4C8A-8697-46E26BF7B0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93731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4A258-A6D2-4347-9425-044DB0CE073A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8F672-1CE0-4C8A-8697-46E26BF7B0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88650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C4A258-A6D2-4347-9425-044DB0CE073A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8F672-1CE0-4C8A-8697-46E26BF7B0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91664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C4A258-A6D2-4347-9425-044DB0CE073A}" type="datetimeFigureOut">
              <a:rPr lang="en-US" smtClean="0"/>
              <a:t>3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F8F672-1CE0-4C8A-8697-46E26BF7B0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45188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536791" y="912387"/>
            <a:ext cx="6489700" cy="5513479"/>
            <a:chOff x="50800" y="734921"/>
            <a:chExt cx="6489700" cy="5513479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2"/>
            <a:srcRect l="38136" t="33222" r="33334" b="27997"/>
            <a:stretch/>
          </p:blipFill>
          <p:spPr>
            <a:xfrm>
              <a:off x="50800" y="734921"/>
              <a:ext cx="6489700" cy="5513479"/>
            </a:xfrm>
            <a:prstGeom prst="rect">
              <a:avLst/>
            </a:prstGeom>
          </p:spPr>
        </p:pic>
        <p:sp>
          <p:nvSpPr>
            <p:cNvPr id="5" name="Rectangle 4"/>
            <p:cNvSpPr/>
            <p:nvPr/>
          </p:nvSpPr>
          <p:spPr>
            <a:xfrm>
              <a:off x="723900" y="4584700"/>
              <a:ext cx="4851400" cy="304800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6" name="Rectangle 5"/>
          <p:cNvSpPr>
            <a:spLocks noChangeArrowheads="1"/>
          </p:cNvSpPr>
          <p:nvPr/>
        </p:nvSpPr>
        <p:spPr bwMode="auto">
          <a:xfrm>
            <a:off x="828937" y="273101"/>
            <a:ext cx="10626179" cy="405247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none" lIns="0" tIns="-12696" rIns="0" bIns="-12696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2800" b="0" i="0" u="none" strike="noStrike" cap="none" normalizeH="0" baseline="0" dirty="0" smtClean="0">
                <a:ln>
                  <a:noFill/>
                </a:ln>
                <a:solidFill>
                  <a:srgbClr val="202124"/>
                </a:solidFill>
                <a:effectLst/>
                <a:latin typeface="inherit"/>
              </a:rPr>
              <a:t>Correlation of different patient’s parameters with</a:t>
            </a:r>
            <a:r>
              <a:rPr kumimoji="0" lang="en-US" altLang="en-US" sz="2800" b="0" i="0" u="none" strike="noStrike" cap="none" normalizeH="0" dirty="0" smtClean="0">
                <a:ln>
                  <a:noFill/>
                </a:ln>
                <a:solidFill>
                  <a:srgbClr val="202124"/>
                </a:solidFill>
                <a:effectLst/>
                <a:latin typeface="inherit"/>
              </a:rPr>
              <a:t> morphology forms</a:t>
            </a:r>
            <a:endParaRPr kumimoji="0" lang="en-US" altLang="en-US" sz="2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" name="Rectangle 8"/>
          <p:cNvSpPr>
            <a:spLocks noChangeArrowheads="1"/>
          </p:cNvSpPr>
          <p:nvPr/>
        </p:nvSpPr>
        <p:spPr bwMode="auto">
          <a:xfrm>
            <a:off x="2198396" y="2696208"/>
            <a:ext cx="2022990" cy="282137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none" lIns="0" tIns="-12696" rIns="0" bIns="-12696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2000" b="0" i="0" u="none" strike="noStrike" cap="none" normalizeH="0" baseline="0" dirty="0" smtClean="0">
                <a:ln>
                  <a:noFill/>
                </a:ln>
                <a:solidFill>
                  <a:srgbClr val="202124"/>
                </a:solidFill>
                <a:effectLst/>
                <a:latin typeface="inherit"/>
              </a:rPr>
              <a:t>Correlation matrix</a:t>
            </a:r>
            <a:endParaRPr kumimoji="0" lang="en-US" altLang="en-US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31744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0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inheri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xey Kononikhin</dc:creator>
  <cp:lastModifiedBy>Alexey Kononikhin</cp:lastModifiedBy>
  <cp:revision>2</cp:revision>
  <dcterms:created xsi:type="dcterms:W3CDTF">2023-03-28T00:32:08Z</dcterms:created>
  <dcterms:modified xsi:type="dcterms:W3CDTF">2023-03-28T00:33:12Z</dcterms:modified>
</cp:coreProperties>
</file>